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856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746783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585550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71363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245336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63345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06606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7862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14918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61360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37288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42218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56C85-65D9-42C1-8E0B-A1CE0395BBAC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6B40C-86CA-4322-A04D-513CA97D5A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13226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4800" y="496888"/>
            <a:ext cx="2011658" cy="18150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0800" y="2503488"/>
            <a:ext cx="2007476" cy="1819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0800" y="4505324"/>
            <a:ext cx="2020023" cy="1819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0618" y="2503488"/>
            <a:ext cx="2015840" cy="1819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76800" y="4505323"/>
            <a:ext cx="2007476" cy="1819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0618" y="4505325"/>
            <a:ext cx="2007476" cy="1819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546094" y="133336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= 0.993</a:t>
            </a:r>
            <a:endParaRPr lang="en-US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3836276" y="536180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= 0.993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6122276" y="536180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= 0.996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3836276" y="335012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= 0.993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1546094" y="536180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= 0.989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1546094" y="335012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= 0.989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2590800" y="495936"/>
            <a:ext cx="43434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/>
                <a:cs typeface="Times New Roman"/>
              </a:rPr>
              <a:t>Additional File 1. </a:t>
            </a:r>
            <a:r>
              <a:rPr lang="en-US" sz="1400" b="1" dirty="0" err="1" smtClean="0">
                <a:latin typeface="Times New Roman"/>
                <a:cs typeface="Times New Roman"/>
              </a:rPr>
              <a:t>Pairwise</a:t>
            </a:r>
            <a:r>
              <a:rPr lang="en-US" sz="1400" b="1" dirty="0" smtClean="0">
                <a:latin typeface="Times New Roman"/>
                <a:cs typeface="Times New Roman"/>
              </a:rPr>
              <a:t> comparisons of barcode frequency for each of the plasmid library sequencing replicates.</a:t>
            </a:r>
          </a:p>
          <a:p>
            <a:r>
              <a:rPr lang="en-US" sz="1400" dirty="0" smtClean="0">
                <a:latin typeface="Times New Roman"/>
                <a:cs typeface="Times New Roman"/>
              </a:rPr>
              <a:t>The frequency of the same barcode in each of the plasmid library sequencing replicates was plotted on a log scale. R-squared values are</a:t>
            </a:r>
            <a:r>
              <a:rPr lang="en-US" sz="1400" dirty="0" smtClean="0">
                <a:latin typeface="Times New Roman"/>
                <a:cs typeface="Times New Roman"/>
              </a:rPr>
              <a:t> given for each </a:t>
            </a:r>
            <a:r>
              <a:rPr lang="en-US" sz="1400" dirty="0" smtClean="0">
                <a:latin typeface="Times New Roman"/>
                <a:cs typeface="Times New Roman"/>
              </a:rPr>
              <a:t>plot. </a:t>
            </a:r>
            <a:endParaRPr lang="en-US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48709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67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Stanford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rteus Lab</dc:creator>
  <cp:lastModifiedBy>Stacey Wirt</cp:lastModifiedBy>
  <cp:revision>6</cp:revision>
  <dcterms:created xsi:type="dcterms:W3CDTF">2013-12-04T01:12:40Z</dcterms:created>
  <dcterms:modified xsi:type="dcterms:W3CDTF">2013-12-04T01:14:03Z</dcterms:modified>
</cp:coreProperties>
</file>